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141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14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3268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351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597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874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262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146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660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045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212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D255F-313F-460E-8B7E-0AAF54BEC621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74952-0D45-4683-8742-DAF9272825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105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FB10F5C1-527B-3038-95AD-C4C0D2B969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0463" y="2339331"/>
            <a:ext cx="3834716" cy="260321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07ACC62-5C8D-436C-D100-52AA8168EAE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286" y="2339331"/>
            <a:ext cx="3834716" cy="26032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41230C4-5915-9C79-1677-6FD34D4D6A72}"/>
              </a:ext>
            </a:extLst>
          </p:cNvPr>
          <p:cNvSpPr txBox="1"/>
          <p:nvPr/>
        </p:nvSpPr>
        <p:spPr>
          <a:xfrm>
            <a:off x="3340197" y="1840017"/>
            <a:ext cx="190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 Cell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D3BF8C-50F7-CF69-B568-0497498A686A}"/>
              </a:ext>
            </a:extLst>
          </p:cNvPr>
          <p:cNvSpPr txBox="1"/>
          <p:nvPr/>
        </p:nvSpPr>
        <p:spPr>
          <a:xfrm>
            <a:off x="7572575" y="1840017"/>
            <a:ext cx="2299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 Infected cell</a:t>
            </a:r>
          </a:p>
        </p:txBody>
      </p:sp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2B337A64-17CF-723E-1BA6-8E4052CB2F2E}"/>
              </a:ext>
            </a:extLst>
          </p:cNvPr>
          <p:cNvSpPr txBox="1"/>
          <p:nvPr/>
        </p:nvSpPr>
        <p:spPr>
          <a:xfrm>
            <a:off x="1938130" y="5138531"/>
            <a:ext cx="9350980" cy="1318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ditional File</a:t>
            </a: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1.</a:t>
            </a:r>
            <a:r>
              <a:rPr lang="en-GB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ARS-CoV-2 isolation from swab sample. (A)  Vero E6 cell control and (B) Vero E6 cells inoculated with swab sample showing cytopathic effect (CPE) at 4 days post inoculation. Magnification is 10x for all images. </a:t>
            </a:r>
          </a:p>
        </p:txBody>
      </p:sp>
    </p:spTree>
    <p:extLst>
      <p:ext uri="{BB962C8B-B14F-4D97-AF65-F5344CB8AC3E}">
        <p14:creationId xmlns:p14="http://schemas.microsoft.com/office/powerpoint/2010/main" val="3439484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游明朝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nisRaymund Tag-at</dc:creator>
  <cp:lastModifiedBy>DennisRaymund Tag-at</cp:lastModifiedBy>
  <cp:revision>1</cp:revision>
  <dcterms:created xsi:type="dcterms:W3CDTF">2023-11-15T02:53:36Z</dcterms:created>
  <dcterms:modified xsi:type="dcterms:W3CDTF">2023-11-15T02:54:07Z</dcterms:modified>
</cp:coreProperties>
</file>